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82160B-D591-4AD5-8841-CABA84218DF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A4E68B-E2B5-41DC-ACC7-AECA36DE2ED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3DED7A-39BE-42F5-8E6A-EB729EC79BB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34845C-D82F-46DC-97DB-6D74729448F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D25EFA-90C9-4750-8200-792C6750215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899BE8-EDCC-4BFE-BD89-29445E96A68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430418-113A-4858-B6BD-E7A834ECACF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A22BF4-5F50-49A5-BEEE-E45435BBF6B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CB4CAA-71F3-43EF-B25F-9CB6429D912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681011-6BD4-4E87-B448-FCFE2AE559A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88D756-628C-4D93-A884-35271F97D9E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15198C-D174-4820-91FE-5EF5E252119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6989154-2521-41A9-A2C3-F106C67ED0D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447920" y="1219320"/>
            <a:ext cx="6400800" cy="4190760"/>
            <a:chOff x="1447920" y="1219320"/>
            <a:chExt cx="6400800" cy="4190760"/>
          </a:xfrm>
        </p:grpSpPr>
        <p:sp>
          <p:nvSpPr>
            <p:cNvPr id="42" name=""/>
            <p:cNvSpPr/>
            <p:nvPr/>
          </p:nvSpPr>
          <p:spPr>
            <a:xfrm>
              <a:off x="2898360" y="1219320"/>
              <a:ext cx="2223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Mouse USV Studies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2732040" y="1828800"/>
              <a:ext cx="2460600" cy="5256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USVs during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Male-female interactio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 flipH="1" rot="2801400">
              <a:off x="3232080" y="2358000"/>
              <a:ext cx="262080" cy="422640"/>
            </a:xfrm>
            <a:prstGeom prst="downArrow">
              <a:avLst>
                <a:gd name="adj1" fmla="val 50000"/>
                <a:gd name="adj2" fmla="val 40316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 anchorCtr="1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4683240" y="2766960"/>
              <a:ext cx="1336680" cy="5256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Female Calls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2514600" y="2766960"/>
              <a:ext cx="1336680" cy="5256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Male USVs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 flipH="1" rot="19236000">
              <a:off x="4823280" y="2371680"/>
              <a:ext cx="281520" cy="395280"/>
            </a:xfrm>
            <a:prstGeom prst="downArrow">
              <a:avLst>
                <a:gd name="adj1" fmla="val 50000"/>
                <a:gd name="adj2" fmla="val 35102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 anchorCtr="1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5105520" y="3733920"/>
              <a:ext cx="2743200" cy="5443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Audible harmonic 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dense-layered calls (squeaks)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5029200" y="4905360"/>
              <a:ext cx="2286000" cy="5047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Index of negative state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2778120" y="3733920"/>
              <a:ext cx="2098800" cy="5252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Frequency-modulated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USVs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1447920" y="3733920"/>
              <a:ext cx="1184040" cy="5252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Flat USVs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 flipH="1" rot="2801400">
              <a:off x="2125080" y="3055680"/>
              <a:ext cx="168480" cy="762120"/>
            </a:xfrm>
            <a:prstGeom prst="downArrow">
              <a:avLst>
                <a:gd name="adj1" fmla="val 50000"/>
                <a:gd name="adj2" fmla="val 113088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 anchorCtr="1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2057400" y="4876920"/>
              <a:ext cx="2438280" cy="5331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Index of positive state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 flipH="1" rot="19236000">
              <a:off x="5510880" y="3265200"/>
              <a:ext cx="282240" cy="515880"/>
            </a:xfrm>
            <a:prstGeom prst="downArrow">
              <a:avLst>
                <a:gd name="adj1" fmla="val 50000"/>
                <a:gd name="adj2" fmla="val 45695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 anchorCtr="1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 flipH="1" rot="21556800">
              <a:off x="3536640" y="3327120"/>
              <a:ext cx="347760" cy="406440"/>
            </a:xfrm>
            <a:prstGeom prst="downArrow">
              <a:avLst>
                <a:gd name="adj1" fmla="val 50000"/>
                <a:gd name="adj2" fmla="val 29218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 anchorCtr="1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 flipH="1" rot="21556800">
              <a:off x="2285280" y="4263840"/>
              <a:ext cx="347760" cy="610920"/>
            </a:xfrm>
            <a:prstGeom prst="downArrow">
              <a:avLst>
                <a:gd name="adj1" fmla="val 50000"/>
                <a:gd name="adj2" fmla="val 43918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 anchorCtr="1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 flipH="1" rot="21556800">
              <a:off x="4037760" y="4265280"/>
              <a:ext cx="347760" cy="609480"/>
            </a:xfrm>
            <a:prstGeom prst="downArrow">
              <a:avLst>
                <a:gd name="adj1" fmla="val 50000"/>
                <a:gd name="adj2" fmla="val 43815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 anchorCtr="1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 flipH="1" rot="21556800">
              <a:off x="6323760" y="4281120"/>
              <a:ext cx="347760" cy="609480"/>
            </a:xfrm>
            <a:prstGeom prst="downArrow">
              <a:avLst>
                <a:gd name="adj1" fmla="val 50000"/>
                <a:gd name="adj2" fmla="val 43815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 anchorCtr="1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1-26T04:29:25Z</dcterms:created>
  <dc:creator>Mary X. Gao</dc:creator>
  <dc:description/>
  <dc:language>en-US</dc:language>
  <cp:lastModifiedBy>U of T</cp:lastModifiedBy>
  <dcterms:modified xsi:type="dcterms:W3CDTF">2008-03-01T18:56:48Z</dcterms:modified>
  <cp:revision>8</cp:revision>
  <dc:subject/>
  <dc:title>Slide 1</dc:title>
</cp:coreProperties>
</file>